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sldIdLst>
    <p:sldId id="271" r:id="rId2"/>
    <p:sldId id="270" r:id="rId3"/>
    <p:sldId id="26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0" autoAdjust="0"/>
    <p:restoredTop sz="94660"/>
  </p:normalViewPr>
  <p:slideViewPr>
    <p:cSldViewPr snapToGrid="0">
      <p:cViewPr>
        <p:scale>
          <a:sx n="201" d="100"/>
          <a:sy n="201" d="100"/>
        </p:scale>
        <p:origin x="1440" y="37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6207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9976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442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8578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0276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8480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172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79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9145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484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1965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AC7FB-BC4A-4756-81B8-AD88382DD5DE}" type="datetimeFigureOut">
              <a:rPr lang="es-ES" smtClean="0"/>
              <a:t>19/9/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DA41A-3571-4CB0-9091-F864FD4B94F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620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a 10">
            <a:extLst>
              <a:ext uri="{FF2B5EF4-FFF2-40B4-BE49-F238E27FC236}">
                <a16:creationId xmlns:a16="http://schemas.microsoft.com/office/drawing/2014/main" xmlns="" id="{92D5DE18-DC88-4BA0-A235-06F97FC8F8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0144998"/>
              </p:ext>
            </p:extLst>
          </p:nvPr>
        </p:nvGraphicFramePr>
        <p:xfrm>
          <a:off x="860038" y="278977"/>
          <a:ext cx="7376032" cy="593659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74245">
                  <a:extLst>
                    <a:ext uri="{9D8B030D-6E8A-4147-A177-3AD203B41FA5}">
                      <a16:colId xmlns:a16="http://schemas.microsoft.com/office/drawing/2014/main" xmlns="" val="2197758328"/>
                    </a:ext>
                  </a:extLst>
                </a:gridCol>
                <a:gridCol w="2065106">
                  <a:extLst>
                    <a:ext uri="{9D8B030D-6E8A-4147-A177-3AD203B41FA5}">
                      <a16:colId xmlns:a16="http://schemas.microsoft.com/office/drawing/2014/main" xmlns="" val="4291352112"/>
                    </a:ext>
                  </a:extLst>
                </a:gridCol>
                <a:gridCol w="1037690">
                  <a:extLst>
                    <a:ext uri="{9D8B030D-6E8A-4147-A177-3AD203B41FA5}">
                      <a16:colId xmlns:a16="http://schemas.microsoft.com/office/drawing/2014/main" xmlns="" val="2273665534"/>
                    </a:ext>
                  </a:extLst>
                </a:gridCol>
                <a:gridCol w="1037690">
                  <a:extLst>
                    <a:ext uri="{9D8B030D-6E8A-4147-A177-3AD203B41FA5}">
                      <a16:colId xmlns:a16="http://schemas.microsoft.com/office/drawing/2014/main" xmlns="" val="1236615597"/>
                    </a:ext>
                  </a:extLst>
                </a:gridCol>
                <a:gridCol w="1027415">
                  <a:extLst>
                    <a:ext uri="{9D8B030D-6E8A-4147-A177-3AD203B41FA5}">
                      <a16:colId xmlns:a16="http://schemas.microsoft.com/office/drawing/2014/main" xmlns="" val="4083081222"/>
                    </a:ext>
                  </a:extLst>
                </a:gridCol>
                <a:gridCol w="1033886">
                  <a:extLst>
                    <a:ext uri="{9D8B030D-6E8A-4147-A177-3AD203B41FA5}">
                      <a16:colId xmlns:a16="http://schemas.microsoft.com/office/drawing/2014/main" xmlns="" val="3595507833"/>
                    </a:ext>
                  </a:extLst>
                </a:gridCol>
              </a:tblGrid>
              <a:tr h="245005"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                      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ephalometri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asurements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1 (n=39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2 (n=44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3 (n=82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4 (n=47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9339659"/>
                  </a:ext>
                </a:extLst>
              </a:tr>
              <a:tr h="184935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600" b="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PROPORTIONAL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-A Face Height (S-Go/N-Me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96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3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.99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8.88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6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2.0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50054600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FH:AFH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3.0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2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0.49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7.3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9.24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74132457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-Ar/Ar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6.09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6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7.8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.0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8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3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8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8676862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FH (N-ANS/(N-ANS+ANS-Me)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2.0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4.0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3.4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4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6.42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4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8803800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FH/TFH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Me:N-M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8.09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8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5.7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9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6.6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3.73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49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77017940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 </a:t>
                      </a:r>
                      <a:r>
                        <a:rPr lang="fr-F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t</a:t>
                      </a:r>
                      <a:r>
                        <a:rPr lang="fr-F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Ratio (N-ANS/ANS-Me) (%)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4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9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6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6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99598011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/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M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3.6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8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61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6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5.4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3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8.33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2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81259180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/Me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6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4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9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05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92804916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/SNB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6.63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9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4.54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8.1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7.6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7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13535283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add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Sella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N-Ar)/ SNA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88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2.4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3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6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4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22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74068231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FH/FMA (MP-FH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8.1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42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3.91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89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6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8.12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8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5.5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9755535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N/SN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6.94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1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2.2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56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7.61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54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2.1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34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58320472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Mx Base (SN-Palatal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 SN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1.50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67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8.41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7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0.8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28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3.7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63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79532434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terior Cranial Base (SN) /Length of Mand Base (G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9.33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11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4.03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1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5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1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2.36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0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22473185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 length (ANS-PNS)/Anterior Cranial Base (SN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5.2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5.3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5.01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6.0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42663012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 length (ANS-PNS)/Midface Length (Co-A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0.3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7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1.5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8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1.0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4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0.9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85134638"/>
                  </a:ext>
                </a:extLst>
              </a:tr>
              <a:tr h="242203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 length (ANS-PNS)/Length of Mand Base (G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18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6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7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4.57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1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16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6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28370305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 Length (Co-A)/Mandibular length (C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2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99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4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89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9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1.56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5772845"/>
                  </a:ext>
                </a:extLst>
              </a:tr>
              <a:tr h="219931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ibular Body Length (G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Mandibular length (C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9.73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1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31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3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0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4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2.103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9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1966429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A/Ar -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04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4.48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4.08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4.8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7596001"/>
                  </a:ext>
                </a:extLst>
              </a:tr>
              <a:tr h="232114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/Post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1.56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5.8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0.87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7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1.0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53868069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 Height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Go)/Posterior Face Height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o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.039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0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9.122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5.0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3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0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4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5240016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/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-ANS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1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6.27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59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.54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7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08958870"/>
                  </a:ext>
                </a:extLst>
              </a:tr>
              <a:tr h="220584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 Height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Go)/Lower Face Height (ANS-Me)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38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61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30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8.80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83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77943853"/>
                  </a:ext>
                </a:extLst>
              </a:tr>
              <a:tr h="219279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N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.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-Na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6.10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05.4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6.4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8.8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4.8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2.91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8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5.7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52203976"/>
                  </a:ext>
                </a:extLst>
              </a:tr>
              <a:tr h="21862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 (A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NB (%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8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79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4.33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97.2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7.00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89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7.4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7.7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5682" marR="5682" marT="5682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13250483"/>
                  </a:ext>
                </a:extLst>
              </a:tr>
            </a:tbl>
          </a:graphicData>
        </a:graphic>
      </p:graphicFrame>
      <p:sp>
        <p:nvSpPr>
          <p:cNvPr id="4" name="object 67">
            <a:extLst>
              <a:ext uri="{FF2B5EF4-FFF2-40B4-BE49-F238E27FC236}">
                <a16:creationId xmlns:a16="http://schemas.microsoft.com/office/drawing/2014/main" xmlns="" id="{98F0AEA7-46D5-4A80-BBFF-1FD970D626B2}"/>
              </a:ext>
            </a:extLst>
          </p:cNvPr>
          <p:cNvSpPr/>
          <p:nvPr/>
        </p:nvSpPr>
        <p:spPr>
          <a:xfrm>
            <a:off x="860038" y="6620524"/>
            <a:ext cx="7515362" cy="127856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5" name="object 66">
            <a:extLst>
              <a:ext uri="{FF2B5EF4-FFF2-40B4-BE49-F238E27FC236}">
                <a16:creationId xmlns:a16="http://schemas.microsoft.com/office/drawing/2014/main" xmlns="" id="{DC7F9ECC-89EF-46A5-A9DB-3DC153D13774}"/>
              </a:ext>
            </a:extLst>
          </p:cNvPr>
          <p:cNvSpPr/>
          <p:nvPr/>
        </p:nvSpPr>
        <p:spPr>
          <a:xfrm>
            <a:off x="860039" y="6575413"/>
            <a:ext cx="7515362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6" name="object 67">
            <a:extLst>
              <a:ext uri="{FF2B5EF4-FFF2-40B4-BE49-F238E27FC236}">
                <a16:creationId xmlns:a16="http://schemas.microsoft.com/office/drawing/2014/main" xmlns="" id="{94AEB489-4DBA-4B85-AE76-EA2BC33D2443}"/>
              </a:ext>
            </a:extLst>
          </p:cNvPr>
          <p:cNvSpPr/>
          <p:nvPr/>
        </p:nvSpPr>
        <p:spPr>
          <a:xfrm>
            <a:off x="860039" y="236685"/>
            <a:ext cx="7376033" cy="77864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7" name="object 66">
            <a:extLst>
              <a:ext uri="{FF2B5EF4-FFF2-40B4-BE49-F238E27FC236}">
                <a16:creationId xmlns:a16="http://schemas.microsoft.com/office/drawing/2014/main" xmlns="" id="{9884CE46-596B-4EB6-BEDD-5860A8BD1DF8}"/>
              </a:ext>
            </a:extLst>
          </p:cNvPr>
          <p:cNvSpPr/>
          <p:nvPr/>
        </p:nvSpPr>
        <p:spPr>
          <a:xfrm>
            <a:off x="860039" y="272095"/>
            <a:ext cx="7376033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86815D7F-E009-40C3-A982-2D1EB845AFCC}"/>
              </a:ext>
            </a:extLst>
          </p:cNvPr>
          <p:cNvSpPr txBox="1"/>
          <p:nvPr/>
        </p:nvSpPr>
        <p:spPr>
          <a:xfrm>
            <a:off x="768600" y="6616519"/>
            <a:ext cx="41094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Helvetica World" panose="020B0500040000020004" pitchFamily="34" charset="0"/>
                <a:cs typeface="Helvetica World" panose="020B0500040000020004" pitchFamily="34" charset="0"/>
              </a:rPr>
              <a:t>Each value represents the mean and standard deviation (SD).</a:t>
            </a:r>
            <a:endParaRPr lang="es-ES" sz="60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10" name="object 2">
            <a:extLst>
              <a:ext uri="{FF2B5EF4-FFF2-40B4-BE49-F238E27FC236}">
                <a16:creationId xmlns:a16="http://schemas.microsoft.com/office/drawing/2014/main" xmlns="" id="{504FA14B-2126-4766-8486-F21EF53AAE3A}"/>
              </a:ext>
            </a:extLst>
          </p:cNvPr>
          <p:cNvSpPr txBox="1"/>
          <p:nvPr/>
        </p:nvSpPr>
        <p:spPr>
          <a:xfrm>
            <a:off x="860039" y="92485"/>
            <a:ext cx="4988858" cy="128401"/>
          </a:xfrm>
          <a:prstGeom prst="rect">
            <a:avLst/>
          </a:prstGeom>
        </p:spPr>
        <p:txBody>
          <a:bodyPr vert="horz" wrap="square" lIns="0" tIns="12859" rIns="0" bIns="0" rtlCol="0">
            <a:spAutoFit/>
          </a:bodyPr>
          <a:lstStyle/>
          <a:p>
            <a:pPr marL="9525">
              <a:spcBef>
                <a:spcPts val="101"/>
              </a:spcBef>
            </a:pPr>
            <a:r>
              <a:rPr lang="es-ES" sz="750" b="1" spc="11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1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</a:t>
            </a:r>
            <a:r>
              <a:rPr lang="es-E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 </a:t>
            </a:r>
            <a:r>
              <a:rPr lang="en-U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Mean values of proportional skeletal variables and supplementary variables. 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172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67">
            <a:extLst>
              <a:ext uri="{FF2B5EF4-FFF2-40B4-BE49-F238E27FC236}">
                <a16:creationId xmlns:a16="http://schemas.microsoft.com/office/drawing/2014/main" xmlns="" id="{98F0AEA7-46D5-4A80-BBFF-1FD970D626B2}"/>
              </a:ext>
            </a:extLst>
          </p:cNvPr>
          <p:cNvSpPr/>
          <p:nvPr/>
        </p:nvSpPr>
        <p:spPr>
          <a:xfrm>
            <a:off x="860038" y="6620524"/>
            <a:ext cx="7515362" cy="127856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5" name="object 66">
            <a:extLst>
              <a:ext uri="{FF2B5EF4-FFF2-40B4-BE49-F238E27FC236}">
                <a16:creationId xmlns:a16="http://schemas.microsoft.com/office/drawing/2014/main" xmlns="" id="{DC7F9ECC-89EF-46A5-A9DB-3DC153D13774}"/>
              </a:ext>
            </a:extLst>
          </p:cNvPr>
          <p:cNvSpPr/>
          <p:nvPr/>
        </p:nvSpPr>
        <p:spPr>
          <a:xfrm>
            <a:off x="860039" y="6575413"/>
            <a:ext cx="7515362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6" name="object 67">
            <a:extLst>
              <a:ext uri="{FF2B5EF4-FFF2-40B4-BE49-F238E27FC236}">
                <a16:creationId xmlns:a16="http://schemas.microsoft.com/office/drawing/2014/main" xmlns="" id="{94AEB489-4DBA-4B85-AE76-EA2BC33D2443}"/>
              </a:ext>
            </a:extLst>
          </p:cNvPr>
          <p:cNvSpPr/>
          <p:nvPr/>
        </p:nvSpPr>
        <p:spPr>
          <a:xfrm>
            <a:off x="860039" y="236685"/>
            <a:ext cx="7376033" cy="77864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7" name="object 66">
            <a:extLst>
              <a:ext uri="{FF2B5EF4-FFF2-40B4-BE49-F238E27FC236}">
                <a16:creationId xmlns:a16="http://schemas.microsoft.com/office/drawing/2014/main" xmlns="" id="{9884CE46-596B-4EB6-BEDD-5860A8BD1DF8}"/>
              </a:ext>
            </a:extLst>
          </p:cNvPr>
          <p:cNvSpPr/>
          <p:nvPr/>
        </p:nvSpPr>
        <p:spPr>
          <a:xfrm>
            <a:off x="860039" y="272095"/>
            <a:ext cx="7376033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graphicFrame>
        <p:nvGraphicFramePr>
          <p:cNvPr id="8" name="Tabla 7">
            <a:extLst>
              <a:ext uri="{FF2B5EF4-FFF2-40B4-BE49-F238E27FC236}">
                <a16:creationId xmlns:a16="http://schemas.microsoft.com/office/drawing/2014/main" xmlns="" id="{5F1B549D-30EA-4E5D-96C8-548B902CD8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3404710"/>
              </p:ext>
            </p:extLst>
          </p:nvPr>
        </p:nvGraphicFramePr>
        <p:xfrm>
          <a:off x="860039" y="319521"/>
          <a:ext cx="7376033" cy="613983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5999">
                  <a:extLst>
                    <a:ext uri="{9D8B030D-6E8A-4147-A177-3AD203B41FA5}">
                      <a16:colId xmlns:a16="http://schemas.microsoft.com/office/drawing/2014/main" xmlns="" val="2225886477"/>
                    </a:ext>
                  </a:extLst>
                </a:gridCol>
                <a:gridCol w="2064250">
                  <a:extLst>
                    <a:ext uri="{9D8B030D-6E8A-4147-A177-3AD203B41FA5}">
                      <a16:colId xmlns:a16="http://schemas.microsoft.com/office/drawing/2014/main" xmlns="" val="3797983720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1202742205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2967466983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3415409228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254374802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1677174726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2045899399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1839954902"/>
                    </a:ext>
                  </a:extLst>
                </a:gridCol>
                <a:gridCol w="518223">
                  <a:extLst>
                    <a:ext uri="{9D8B030D-6E8A-4147-A177-3AD203B41FA5}">
                      <a16:colId xmlns:a16="http://schemas.microsoft.com/office/drawing/2014/main" xmlns="" val="2639286122"/>
                    </a:ext>
                  </a:extLst>
                </a:gridCol>
              </a:tblGrid>
              <a:tr h="200088"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ephalometric</a:t>
                      </a:r>
                      <a:r>
                        <a:rPr lang="es-E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asurements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1 (n=21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2 (n=40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3 (n=70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4 (n=8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extLst>
                  <a:ext uri="{0D108BD9-81ED-4DB2-BD59-A6C34878D82A}">
                    <a16:rowId xmlns:a16="http://schemas.microsoft.com/office/drawing/2014/main" xmlns="" val="505356621"/>
                  </a:ext>
                </a:extLst>
              </a:tr>
              <a:tr h="182660">
                <a:tc>
                  <a:txBody>
                    <a:bodyPr/>
                    <a:lstStyle/>
                    <a:p>
                      <a:pPr algn="l" fontAlgn="b"/>
                      <a:endParaRPr lang="es-E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ANGULA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H - SN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6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7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25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30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58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1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2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38470125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A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3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3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8.1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0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56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0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36038146"/>
                  </a:ext>
                </a:extLst>
              </a:tr>
              <a:tr h="13997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B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3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3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8.8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7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81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69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4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2543814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B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9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5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4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5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4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0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1573823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D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5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6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7.0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91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7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0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0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3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13280650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Y-Axis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SN)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5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9.0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3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5.5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9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3.7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9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65649414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2.40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1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7.67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01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2.9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4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24951815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o-Mx Base/SN-Palatal Plane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2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6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4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3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56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6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1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6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5012474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N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44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7.2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30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32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.1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15147955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 Plane to FH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8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9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99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99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6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4859273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ial Axis-Ricketts (NaBa-PtGn)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9.1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2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7.37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3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1.57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3.93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15901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MA (MP-FH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3.6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1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39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9.4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9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2499489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Face Height (ANS-Xi-Pm)(º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7.08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3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4.4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7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3.5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6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7.9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5572424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ial Angle (FH-NPo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4.24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1.32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98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3.22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5.7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5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5658064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A-Pg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4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7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8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9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7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1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3655732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ial Taper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2.1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1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5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27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2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1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3605595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ni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/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Jaw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r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Me)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4.3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5.28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3.78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7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4.9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24451745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Upper Gonial Angle (Ar-Go-Na) (º)</a:t>
                      </a:r>
                      <a:endParaRPr lang="pt-BR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7.63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1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9.8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5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0.6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3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7.77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7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7036364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Lower Gonial Angle (Na-Go-Me) (º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6.7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9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5.4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3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3.1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4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17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7889649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 Angle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5.6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4.77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1.11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6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3.7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17300097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addle/Sella Angle (SN-Ar) (º)</a:t>
                      </a:r>
                      <a:endParaRPr lang="nb-NO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4.2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5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5.36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26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4.90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6.44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1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7143669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up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N-AB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0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0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5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3.67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41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6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7238924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p-FH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2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1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8.8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5.7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8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0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63113931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2864107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9904681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LINE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terior Cranial Base (SN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6.19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20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58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9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0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2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8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4853097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terior Face Height (NaMe)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3.24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08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9.97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9.45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1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3.7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4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57601838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 Face Height (N-ANS)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1.89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6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3.19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2.13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3.0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1421135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Face Height (ANS-Me)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1.83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5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5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67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94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1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1.2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0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48787014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Cranial Base (S-Ar) (mm)</a:t>
                      </a:r>
                      <a:endParaRPr lang="pt-BR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14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5.20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6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4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6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7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939979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Face Height (SGo)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8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84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6.74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61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31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7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0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3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37436833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 Height (Ar-Go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0.32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0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5.3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3.5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96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2.51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7763557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Go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5.2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90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0.54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3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8.60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44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7.4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71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29738838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 (A-NPo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3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3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2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9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7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83085870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 Skeletal (A-Na Perp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0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3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7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92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2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2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340763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 Length (Co-A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60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08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68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9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6.1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6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66182495"/>
                  </a:ext>
                </a:extLst>
              </a:tr>
              <a:tr h="144122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A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2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2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3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01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22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0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35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1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2000600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 length (ANS-PNS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9.8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8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0.8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97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2.5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1.5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5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92194203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 - NB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55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9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5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6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79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9448343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. Skeletal (Pg-Na Perp) (mm)</a:t>
                      </a:r>
                      <a:endParaRPr lang="da-DK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5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08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6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6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1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19261659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ibular Body Length (Go-Gn)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6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1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89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3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38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4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35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0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4167691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 of Mand Base (Go-Pg)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4.2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62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1.95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4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3.5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2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32140794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ibular length (Co-Gn)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3.04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.05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6.47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1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1.5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9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8.33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35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12712953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B1 Total mand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0.6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6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4.42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9.2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6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5.6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06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18706511"/>
                  </a:ext>
                </a:extLst>
              </a:tr>
              <a:tr h="123200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6.3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87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9.18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3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5.06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0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2.79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43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25355626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asal Width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45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0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1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3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88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8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6052583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x/Md diff (Co-Gn - Co-A)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0.44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8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7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1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5.37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8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74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7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9463790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Wits (FOP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7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3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0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6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38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8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74931672"/>
                  </a:ext>
                </a:extLst>
              </a:tr>
              <a:tr h="11878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Wits Appraisal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59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5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9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0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95551365"/>
                  </a:ext>
                </a:extLst>
              </a:tr>
            </a:tbl>
          </a:graphicData>
        </a:graphic>
      </p:graphicFrame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86815D7F-E009-40C3-A982-2D1EB845AFCC}"/>
              </a:ext>
            </a:extLst>
          </p:cNvPr>
          <p:cNvSpPr txBox="1"/>
          <p:nvPr/>
        </p:nvSpPr>
        <p:spPr>
          <a:xfrm>
            <a:off x="768600" y="6616519"/>
            <a:ext cx="41094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Helvetica World" panose="020B0500040000020004" pitchFamily="34" charset="0"/>
                <a:cs typeface="Helvetica World" panose="020B0500040000020004" pitchFamily="34" charset="0"/>
              </a:rPr>
              <a:t>Each value represents the mean and standard deviation (SD).</a:t>
            </a:r>
            <a:endParaRPr lang="es-ES" sz="60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10" name="object 2">
            <a:extLst>
              <a:ext uri="{FF2B5EF4-FFF2-40B4-BE49-F238E27FC236}">
                <a16:creationId xmlns:a16="http://schemas.microsoft.com/office/drawing/2014/main" xmlns="" id="{504FA14B-2126-4766-8486-F21EF53AAE3A}"/>
              </a:ext>
            </a:extLst>
          </p:cNvPr>
          <p:cNvSpPr txBox="1"/>
          <p:nvPr/>
        </p:nvSpPr>
        <p:spPr>
          <a:xfrm>
            <a:off x="860039" y="92485"/>
            <a:ext cx="4988858" cy="128401"/>
          </a:xfrm>
          <a:prstGeom prst="rect">
            <a:avLst/>
          </a:prstGeom>
        </p:spPr>
        <p:txBody>
          <a:bodyPr vert="horz" wrap="square" lIns="0" tIns="12859" rIns="0" bIns="0" rtlCol="0">
            <a:spAutoFit/>
          </a:bodyPr>
          <a:lstStyle/>
          <a:p>
            <a:pPr marL="9525">
              <a:spcBef>
                <a:spcPts val="101"/>
              </a:spcBef>
            </a:pPr>
            <a:r>
              <a:rPr lang="es-ES" sz="750" b="1" spc="11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1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</a:t>
            </a:r>
            <a:r>
              <a:rPr lang="es-E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 </a:t>
            </a:r>
            <a:r>
              <a:rPr lang="en-U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Mean values of proportional skeletal variables and supplementary variables. 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2955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xmlns="" id="{B3B95621-F9E7-4654-A585-D0ABC5911F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8849941"/>
              </p:ext>
            </p:extLst>
          </p:nvPr>
        </p:nvGraphicFramePr>
        <p:xfrm>
          <a:off x="860042" y="331209"/>
          <a:ext cx="7376025" cy="62460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5998">
                  <a:extLst>
                    <a:ext uri="{9D8B030D-6E8A-4147-A177-3AD203B41FA5}">
                      <a16:colId xmlns:a16="http://schemas.microsoft.com/office/drawing/2014/main" xmlns="" val="511481278"/>
                    </a:ext>
                  </a:extLst>
                </a:gridCol>
                <a:gridCol w="2064251">
                  <a:extLst>
                    <a:ext uri="{9D8B030D-6E8A-4147-A177-3AD203B41FA5}">
                      <a16:colId xmlns:a16="http://schemas.microsoft.com/office/drawing/2014/main" xmlns="" val="1253321489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713955562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2925941697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4216742703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1059761670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940019487"/>
                    </a:ext>
                  </a:extLst>
                </a:gridCol>
                <a:gridCol w="518222">
                  <a:extLst>
                    <a:ext uri="{9D8B030D-6E8A-4147-A177-3AD203B41FA5}">
                      <a16:colId xmlns:a16="http://schemas.microsoft.com/office/drawing/2014/main" xmlns="" val="420032069"/>
                    </a:ext>
                  </a:extLst>
                </a:gridCol>
                <a:gridCol w="512691">
                  <a:extLst>
                    <a:ext uri="{9D8B030D-6E8A-4147-A177-3AD203B41FA5}">
                      <a16:colId xmlns:a16="http://schemas.microsoft.com/office/drawing/2014/main" xmlns="" val="1708137955"/>
                    </a:ext>
                  </a:extLst>
                </a:gridCol>
                <a:gridCol w="523753">
                  <a:extLst>
                    <a:ext uri="{9D8B030D-6E8A-4147-A177-3AD203B41FA5}">
                      <a16:colId xmlns:a16="http://schemas.microsoft.com/office/drawing/2014/main" xmlns="" val="3947012338"/>
                    </a:ext>
                  </a:extLst>
                </a:gridCol>
              </a:tblGrid>
              <a:tr h="187732"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ephalometric</a:t>
                      </a:r>
                      <a:r>
                        <a:rPr lang="es-E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asurements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1 (n=21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2 (n=40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3 (n=70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4 (n=8)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199" marR="4199" marT="419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s-E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199" marR="4199" marT="4199" marB="0" anchor="b"/>
                </a:tc>
                <a:extLst>
                  <a:ext uri="{0D108BD9-81ED-4DB2-BD59-A6C34878D82A}">
                    <a16:rowId xmlns:a16="http://schemas.microsoft.com/office/drawing/2014/main" xmlns="" val="922143068"/>
                  </a:ext>
                </a:extLst>
              </a:tr>
              <a:tr h="95459">
                <a:tc>
                  <a:txBody>
                    <a:bodyPr/>
                    <a:lstStyle/>
                    <a:p>
                      <a:pPr algn="l" fontAlgn="b"/>
                      <a:endParaRPr lang="es-E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ENTAL ANGULA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Interincis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U1-L1)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6.0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7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7.37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9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3.99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49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0.6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.07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1781117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NA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6.3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88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3.6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8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6.8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0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92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0068510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SN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6.7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62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1.77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7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7.37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9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6.04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8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82265178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Palatal Plane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3.9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5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1.2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2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5.93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29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6.07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83385081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FH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7.3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83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3.02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7.6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7.2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49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78033448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NB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9.60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2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9.7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4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0.44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8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6.0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4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87416119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to A-Po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1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71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3.1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0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62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2.17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92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5536630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FH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3.4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0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4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1.67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2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7.89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0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7042444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IMPA (L1-MP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9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34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5.44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4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8.82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6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8.2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61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37129904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6 long axis - MP (º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10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75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49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90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8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92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60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6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39489849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25209721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76276717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ENTAL LINE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verjet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2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1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2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2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2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3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53371216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verbite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6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9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1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1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1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5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4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27971"/>
                  </a:ext>
                </a:extLst>
              </a:tr>
              <a:tr h="10021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NA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6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0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2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08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1913537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to Occlusal Plane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16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2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74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24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4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3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61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1399722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PP (UADH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0.0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8.29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7.91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7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3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1019486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to Nasion Perp (mm)</a:t>
                      </a:r>
                      <a:endParaRPr lang="pl-PL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0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2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5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6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9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14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2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9895626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NB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2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8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33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5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48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5547291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Protrusion (L1-APo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0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8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5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2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30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54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5465436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to Occlusal Plane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77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0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5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9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8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3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29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49027100"/>
                  </a:ext>
                </a:extLst>
              </a:tr>
              <a:tr h="11538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MP (LADH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0.6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2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9.41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9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0.61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3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7.75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3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9592161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Tip - VRP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8.2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62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46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5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1.18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02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8.32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70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0802375"/>
                  </a:ext>
                </a:extLst>
              </a:tr>
              <a:tr h="86066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6 - PT Vertical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7.21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3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20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8.24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6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7.92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3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80471970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6 - PP (UPDH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5.2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3.26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4.42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8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2.32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7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19063704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6 - MP (LPDH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2.20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85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0.90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8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2.6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1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0.89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0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4526904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olar Relation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4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2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6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03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6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2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277262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4150596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22184147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ANGUL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LA (Nasal Angle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9.76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24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3.48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19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1.6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33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3.27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10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521985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ial Convexity (G'-Sn-Po'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1.4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1.49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1.9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1.1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6.76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0.99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9.30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6.4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43953066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-Angle (Pg'UL-Pg'Na')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25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4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56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63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5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5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77357010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0674153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2262037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LINE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 Lip - S Line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85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3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0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41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0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49531417"/>
                  </a:ext>
                </a:extLst>
              </a:tr>
              <a:tr h="103483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 Lip - VRP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4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81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7.87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11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83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82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3.0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6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8747441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 N Vert (N Perp) to Upper Lip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34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0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38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83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52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31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99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48325432"/>
                  </a:ext>
                </a:extLst>
              </a:tr>
              <a:tr h="10125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Lip - S Line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0.8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12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7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6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.1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7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48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6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80086579"/>
                  </a:ext>
                </a:extLst>
              </a:tr>
              <a:tr h="114874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Lip to E-Plane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0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38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9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60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1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5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80895130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Lip - VRP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2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16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6.79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4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4.59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97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2.22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7515976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 N Vert (N Perp) to Lower Lip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6.10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05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3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2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39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39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3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1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36806686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 N Vert (N Perp) to ST Pogonion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68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7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0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4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.42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4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7.70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27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9640594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'-Me'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3.76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76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9.68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1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0.71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10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4.0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.42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1514783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1442435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8237660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PROPORTIONS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'-sn'/sn'-me' (%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0.3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4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6.9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69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3.78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2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0.70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37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32109087"/>
                  </a:ext>
                </a:extLst>
              </a:tr>
              <a:tr h="91069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'-sn'/sn'-gn' (%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5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99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7.05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47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4.04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0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2.8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54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13237811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Stomion / Sn-Me (%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01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296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48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6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7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77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3.14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5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0991759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5122742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39148129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 WAYS ANGUL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PT - NS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1.17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74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43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6.03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55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19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99.03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55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80898542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48478978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53897796"/>
                  </a:ext>
                </a:extLst>
              </a:tr>
              <a:tr h="138049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 WAY LINEAR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Airway: Oro-pharyngeal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0.82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35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241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6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1.2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13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2.23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77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288958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 Airway: Naso-pharyngeal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37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2.86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3.3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84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5.63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14.53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3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6191889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terior nasal cavity height (mm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0.43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874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9.92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719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9.610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0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6.985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53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52223536"/>
                  </a:ext>
                </a:extLst>
              </a:tr>
              <a:tr h="101685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nasal cavity height (mm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6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401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1.6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.16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0.339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90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9.1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.15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62363563"/>
                  </a:ext>
                </a:extLst>
              </a:tr>
              <a:tr h="78357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 - PP (ANS-PNS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1.17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927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8.36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7.618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61.838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40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58.766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8.78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7088725"/>
                  </a:ext>
                </a:extLst>
              </a:tr>
              <a:tr h="10023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NS to Basion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3.323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62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2.034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90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4.41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.482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44.187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Helvetica World" panose="020B0500040000020004" pitchFamily="34" charset="0"/>
                          <a:ea typeface="+mn-ea"/>
                          <a:cs typeface="Helvetica World" panose="020B0500040000020004" pitchFamily="34" charset="0"/>
                        </a:rPr>
                        <a:t>±</a:t>
                      </a:r>
                      <a:r>
                        <a:rPr lang="en-US" sz="6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600" u="none" strike="noStrike" dirty="0" smtClean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3.755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688" marR="3688" marT="368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62266430"/>
                  </a:ext>
                </a:extLst>
              </a:tr>
            </a:tbl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2C2531A7-205D-4E91-91AC-39F882AF7A57}"/>
              </a:ext>
            </a:extLst>
          </p:cNvPr>
          <p:cNvSpPr txBox="1"/>
          <p:nvPr/>
        </p:nvSpPr>
        <p:spPr>
          <a:xfrm>
            <a:off x="768600" y="6632995"/>
            <a:ext cx="41094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Helvetica World" panose="020B0500040000020004" pitchFamily="34" charset="0"/>
                <a:cs typeface="Helvetica World" panose="020B0500040000020004" pitchFamily="34" charset="0"/>
              </a:rPr>
              <a:t>Each value represents the mean and standard deviation (SD).</a:t>
            </a:r>
            <a:endParaRPr lang="es-ES" sz="60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10" name="object 2">
            <a:extLst>
              <a:ext uri="{FF2B5EF4-FFF2-40B4-BE49-F238E27FC236}">
                <a16:creationId xmlns:a16="http://schemas.microsoft.com/office/drawing/2014/main" xmlns="" id="{EB61198E-02F0-4EB0-9781-D48C548F8751}"/>
              </a:ext>
            </a:extLst>
          </p:cNvPr>
          <p:cNvSpPr txBox="1"/>
          <p:nvPr/>
        </p:nvSpPr>
        <p:spPr>
          <a:xfrm>
            <a:off x="860039" y="92485"/>
            <a:ext cx="4988858" cy="128401"/>
          </a:xfrm>
          <a:prstGeom prst="rect">
            <a:avLst/>
          </a:prstGeom>
        </p:spPr>
        <p:txBody>
          <a:bodyPr vert="horz" wrap="square" lIns="0" tIns="12859" rIns="0" bIns="0" rtlCol="0">
            <a:spAutoFit/>
          </a:bodyPr>
          <a:lstStyle/>
          <a:p>
            <a:pPr marL="9525">
              <a:spcBef>
                <a:spcPts val="101"/>
              </a:spcBef>
            </a:pPr>
            <a:r>
              <a:rPr lang="es-ES" sz="750" b="1" spc="11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1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</a:t>
            </a:r>
            <a:r>
              <a:rPr lang="es-E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 </a:t>
            </a:r>
            <a:r>
              <a:rPr lang="en-US" sz="750" b="1" spc="11" dirty="0">
                <a:latin typeface="Helvetica World" panose="020B0500040000020004" pitchFamily="34" charset="0"/>
                <a:cs typeface="Helvetica World" panose="020B0500040000020004" pitchFamily="34" charset="0"/>
              </a:rPr>
              <a:t>Mean values of proportional skeletal variables and supplementary variables. 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11" name="object 67">
            <a:extLst>
              <a:ext uri="{FF2B5EF4-FFF2-40B4-BE49-F238E27FC236}">
                <a16:creationId xmlns:a16="http://schemas.microsoft.com/office/drawing/2014/main" xmlns="" id="{72CF8123-2AAF-4FCB-A005-0664B437ED07}"/>
              </a:ext>
            </a:extLst>
          </p:cNvPr>
          <p:cNvSpPr/>
          <p:nvPr/>
        </p:nvSpPr>
        <p:spPr>
          <a:xfrm>
            <a:off x="860039" y="236685"/>
            <a:ext cx="7376033" cy="77864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12" name="object 66">
            <a:extLst>
              <a:ext uri="{FF2B5EF4-FFF2-40B4-BE49-F238E27FC236}">
                <a16:creationId xmlns:a16="http://schemas.microsoft.com/office/drawing/2014/main" xmlns="" id="{B837975A-0B7B-4008-B1D9-D7F9A5DA721D}"/>
              </a:ext>
            </a:extLst>
          </p:cNvPr>
          <p:cNvSpPr/>
          <p:nvPr/>
        </p:nvSpPr>
        <p:spPr>
          <a:xfrm>
            <a:off x="860039" y="272095"/>
            <a:ext cx="7376033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13" name="object 67">
            <a:extLst>
              <a:ext uri="{FF2B5EF4-FFF2-40B4-BE49-F238E27FC236}">
                <a16:creationId xmlns:a16="http://schemas.microsoft.com/office/drawing/2014/main" xmlns="" id="{DB17C6B8-C078-4572-A70A-AE308D1F0C71}"/>
              </a:ext>
            </a:extLst>
          </p:cNvPr>
          <p:cNvSpPr/>
          <p:nvPr/>
        </p:nvSpPr>
        <p:spPr>
          <a:xfrm>
            <a:off x="860038" y="6620524"/>
            <a:ext cx="7515362" cy="127856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  <p:sp>
        <p:nvSpPr>
          <p:cNvPr id="14" name="object 66">
            <a:extLst>
              <a:ext uri="{FF2B5EF4-FFF2-40B4-BE49-F238E27FC236}">
                <a16:creationId xmlns:a16="http://schemas.microsoft.com/office/drawing/2014/main" xmlns="" id="{D2FE54E1-6003-443D-B069-BFC6F20CD017}"/>
              </a:ext>
            </a:extLst>
          </p:cNvPr>
          <p:cNvSpPr/>
          <p:nvPr/>
        </p:nvSpPr>
        <p:spPr>
          <a:xfrm>
            <a:off x="860039" y="6575413"/>
            <a:ext cx="7515362" cy="159949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350"/>
          </a:p>
        </p:txBody>
      </p:sp>
    </p:spTree>
    <p:extLst>
      <p:ext uri="{BB962C8B-B14F-4D97-AF65-F5344CB8AC3E}">
        <p14:creationId xmlns:p14="http://schemas.microsoft.com/office/powerpoint/2010/main" val="26073758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39</TotalTime>
  <Words>2856</Words>
  <Application>Microsoft Macintosh PowerPoint</Application>
  <PresentationFormat>Presentación en pantalla (4:3)</PresentationFormat>
  <Paragraphs>633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o Iglesias Linares</dc:creator>
  <cp:lastModifiedBy>Leixuri</cp:lastModifiedBy>
  <cp:revision>94</cp:revision>
  <dcterms:created xsi:type="dcterms:W3CDTF">2018-03-20T16:49:51Z</dcterms:created>
  <dcterms:modified xsi:type="dcterms:W3CDTF">2020-09-19T10:08:38Z</dcterms:modified>
</cp:coreProperties>
</file>